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8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E73B48-6F98-49F6-B144-B6DAD18A8C8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1120B90-C5EB-45C4-8D07-B2E3548037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D60224-2759-4AE7-9FF5-F70A352E9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9328E-C4FC-49B4-9FB8-E2B4956E2136}" type="datetimeFigureOut">
              <a:rPr lang="en-IN" smtClean="0"/>
              <a:t>18-12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9C06DA-CA66-44F4-AE5E-7F0408343A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325BEE-E48B-42BE-BCF6-A6F1A66CC1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B4D3-6592-459D-AAE5-4968FD6456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07623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DCD68E-0074-4960-8C2E-0B397E227E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FC7178-4476-4F09-A66B-6D2ECEAF62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0CA090-6859-46F5-959A-5F289D461B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9328E-C4FC-49B4-9FB8-E2B4956E2136}" type="datetimeFigureOut">
              <a:rPr lang="en-IN" smtClean="0"/>
              <a:t>18-12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F25034-1808-41F3-B7B8-CCFD906364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78CEDB-D183-4164-9A85-0AF233180D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B4D3-6592-459D-AAE5-4968FD6456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66942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EB2D023-64BD-4D2B-BABC-6CE7D26F203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94FC69-F219-4FF0-B281-D6A3EE4EFB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A57764-57EF-4481-AB50-E912DA25B1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9328E-C4FC-49B4-9FB8-E2B4956E2136}" type="datetimeFigureOut">
              <a:rPr lang="en-IN" smtClean="0"/>
              <a:t>18-12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537FEB-E506-4BB6-99B4-8B80D57C7B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D3AABC-4574-4A31-AE0E-49FAD1E9D4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B4D3-6592-459D-AAE5-4968FD6456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86359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57C8B2-9225-451D-900F-77861F4081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D69A53-4469-4285-9291-8C28CB5688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210031-EE37-4621-B49A-9CEA789975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9328E-C4FC-49B4-9FB8-E2B4956E2136}" type="datetimeFigureOut">
              <a:rPr lang="en-IN" smtClean="0"/>
              <a:t>18-12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C70A12-7A8C-4DB7-9919-36CCB2EC21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5E9247-FE76-4F75-8B09-CCAB095E6D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B4D3-6592-459D-AAE5-4968FD6456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77452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8B7A1A-451C-42E5-BF22-648A1245ED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89DFA0-F59B-4DE4-848F-3FA356D40C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25105D-0ABF-4530-8F11-0307254CAE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9328E-C4FC-49B4-9FB8-E2B4956E2136}" type="datetimeFigureOut">
              <a:rPr lang="en-IN" smtClean="0"/>
              <a:t>18-12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23A6B8-89AE-4AF6-95DE-75CE6E0EE8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84FD77-A0A4-4E29-B005-E5E990EFA9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B4D3-6592-459D-AAE5-4968FD6456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493420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65F67A-26B0-4664-BCD7-BF87C70051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5067E4-EEC9-4A6A-9A04-D83B2CB80C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AEC94E-CF54-4F57-BBD5-430855DC1A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C4780B-8605-40E9-B616-3623B61778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9328E-C4FC-49B4-9FB8-E2B4956E2136}" type="datetimeFigureOut">
              <a:rPr lang="en-IN" smtClean="0"/>
              <a:t>18-12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6E8401-FAF1-4B24-B7E3-A30F2A263F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76FC50-1795-4891-A4CA-7315D59409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B4D3-6592-459D-AAE5-4968FD6456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479446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CD4AED-9694-4C32-B3A2-6A8954846D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955A24-76D9-486E-9004-7307AFDABB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B3B6284-91AE-4C72-8FED-8E14CD8184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58A6ABD-AA2C-4D5F-8D31-6F698B9FB4A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0BB38B3-EAA9-4F68-B745-B7F3533365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ABA7229-A5EF-4573-9846-74E1991AA8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9328E-C4FC-49B4-9FB8-E2B4956E2136}" type="datetimeFigureOut">
              <a:rPr lang="en-IN" smtClean="0"/>
              <a:t>18-12-2021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BA14190-56EF-455C-B7D4-6FFA2D1DF4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25113C8-4F75-42C8-B4A1-774357756E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B4D3-6592-459D-AAE5-4968FD6456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600636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7D6E7A-38E2-4A7C-AF9D-FCC2F4D5C5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8F685F5-422A-4F87-B921-B408F10A2B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9328E-C4FC-49B4-9FB8-E2B4956E2136}" type="datetimeFigureOut">
              <a:rPr lang="en-IN" smtClean="0"/>
              <a:t>18-12-2021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89A5D6C-6D6C-4FAD-843C-9BC0821683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7BC3212-144B-4560-8B57-7BABE2AE09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B4D3-6592-459D-AAE5-4968FD6456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84333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E24629A-275D-471F-B554-307D05DE56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9328E-C4FC-49B4-9FB8-E2B4956E2136}" type="datetimeFigureOut">
              <a:rPr lang="en-IN" smtClean="0"/>
              <a:t>18-12-2021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5B16AB2-B2BE-4848-97F0-149D3BF228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876216B-B79F-4FD3-BD39-0C21359592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B4D3-6592-459D-AAE5-4968FD6456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24156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DA827B-B8D7-4726-A9B5-284ED5997A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07C652-635F-438A-83FF-377AE68BA1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0415639-3A2C-4FB9-A496-17C4A2B543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F1922D-BF7B-4D78-8A4C-5B70F356B9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9328E-C4FC-49B4-9FB8-E2B4956E2136}" type="datetimeFigureOut">
              <a:rPr lang="en-IN" smtClean="0"/>
              <a:t>18-12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63DABF-5D39-47BC-A128-98F5E24F09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926D44D-DF25-4775-8C2F-034224B1A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B4D3-6592-459D-AAE5-4968FD6456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151605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AF94E2-2C0D-44EC-B0BA-BFFBCA75AD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567B2A5-141A-4042-BABB-C0AE13747A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9E72426-05F8-43AE-9A71-69A01A0D63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2C7524-B832-4E1F-AE02-3A3F1E2E05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9328E-C4FC-49B4-9FB8-E2B4956E2136}" type="datetimeFigureOut">
              <a:rPr lang="en-IN" smtClean="0"/>
              <a:t>18-12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E70B7E-97E2-4F2D-8267-059A68A67F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C74926-2AD4-4517-8141-9AB71B274C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B4D3-6592-459D-AAE5-4968FD6456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542851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0CDF2CB-41B9-4A51-A937-B675FF58E9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F50AFC-679F-44B7-B305-1CEF2EC1AE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805DF4-B156-457B-AE94-88A4F192D8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89328E-C4FC-49B4-9FB8-E2B4956E2136}" type="datetimeFigureOut">
              <a:rPr lang="en-IN" smtClean="0"/>
              <a:t>18-12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39981E-76C3-4993-9A1F-E71751975D6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D46857-4D19-492A-980F-C9A385884F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40B4D3-6592-459D-AAE5-4968FD6456B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91428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A182A114-D077-4C10-BA95-40C751F5676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84120" y="3210560"/>
            <a:ext cx="7403541" cy="29159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4AADC9D-8893-4CAE-B134-0B9FF54C5197}"/>
              </a:ext>
            </a:extLst>
          </p:cNvPr>
          <p:cNvSpPr txBox="1"/>
          <p:nvPr/>
        </p:nvSpPr>
        <p:spPr>
          <a:xfrm>
            <a:off x="2307185" y="508000"/>
            <a:ext cx="870625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Immunoblot representing prevention of prion-induced </a:t>
            </a:r>
            <a:r>
              <a:rPr lang="en-US" sz="18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talin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proteolysis by fibrinogen</a:t>
            </a:r>
            <a:endParaRPr lang="en-IN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7D1AEF4-FE44-4CF8-9166-87A7102C2522}"/>
              </a:ext>
            </a:extLst>
          </p:cNvPr>
          <p:cNvSpPr txBox="1"/>
          <p:nvPr/>
        </p:nvSpPr>
        <p:spPr>
          <a:xfrm rot="16200000">
            <a:off x="3505200" y="2814320"/>
            <a:ext cx="11379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MSO</a:t>
            </a:r>
            <a:endParaRPr lang="en-IN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E71FCA0-6B71-4BE2-B92E-7430113E905D}"/>
              </a:ext>
            </a:extLst>
          </p:cNvPr>
          <p:cNvSpPr txBox="1"/>
          <p:nvPr/>
        </p:nvSpPr>
        <p:spPr>
          <a:xfrm rot="16200000">
            <a:off x="3905012" y="2814320"/>
            <a:ext cx="11379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23187</a:t>
            </a:r>
            <a:endParaRPr lang="en-IN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3CBC4FF-23CA-4038-83F6-D719C1A84243}"/>
              </a:ext>
            </a:extLst>
          </p:cNvPr>
          <p:cNvSpPr txBox="1"/>
          <p:nvPr/>
        </p:nvSpPr>
        <p:spPr>
          <a:xfrm rot="16200000">
            <a:off x="3997068" y="2442586"/>
            <a:ext cx="18813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rP</a:t>
            </a:r>
            <a:r>
              <a:rPr lang="en-US" dirty="0"/>
              <a:t> (106-126)</a:t>
            </a:r>
            <a:endParaRPr lang="en-IN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937C4F0-FEFD-48B8-9793-63599E4FF56B}"/>
              </a:ext>
            </a:extLst>
          </p:cNvPr>
          <p:cNvSpPr txBox="1"/>
          <p:nvPr/>
        </p:nvSpPr>
        <p:spPr>
          <a:xfrm rot="16200000">
            <a:off x="4334134" y="2370573"/>
            <a:ext cx="20828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Fg+PrP</a:t>
            </a:r>
            <a:r>
              <a:rPr lang="en-US" dirty="0"/>
              <a:t> (106-126)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888033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1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utamdeepa@yahoo.com</dc:creator>
  <cp:lastModifiedBy>gautamdeepa@yahoo.com</cp:lastModifiedBy>
  <cp:revision>1</cp:revision>
  <dcterms:created xsi:type="dcterms:W3CDTF">2021-12-18T19:44:47Z</dcterms:created>
  <dcterms:modified xsi:type="dcterms:W3CDTF">2021-12-18T19:52:11Z</dcterms:modified>
</cp:coreProperties>
</file>